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21AAF-D0A5-471B-AB2A-4B878700C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8D7D80-3A21-46F4-ABA4-C207FCDE5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B04063-0143-4401-AF85-9C746A16E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9A0426-B7EE-4562-A266-26F300EC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1E37DD-A18A-42BC-A267-20A3A8931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95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161C8A-2A7D-42D4-A118-0E161E383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2A9ED7-80C3-4E28-B9A4-C1BC85840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42864C-C2E0-4A29-B3D5-D9564E9C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69F4D1-70BB-4F7D-BC76-3E8F8CFC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D6FAA4-7D49-4741-A9F6-0A9935D0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06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D50870-3898-4BDB-9347-AFD447229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C44191-EED9-4FEF-B8F8-11A930130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9FBD3-37B3-4037-9A4B-247BE8328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512FB6-C19C-42EF-8A20-76671BFE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03CAF1-A8C2-4BFC-82B1-F414B679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02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AC1358-C278-486D-96A7-D7EE2678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96B36-DC6C-4128-81F4-B8CC92432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106111-F22D-4E93-A27C-1718BE0D1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F742F-7B50-4ED5-9FAA-4B470C075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3246A-876F-4FA2-8B81-0396A14D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17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9FE43-D367-4BF1-9199-F3CAE9F19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29400-4781-49AB-B003-F9901C356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357CC-B8B8-4DD9-AC1F-57D3E3E2C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35705-77CF-44DE-9734-F1AD9868D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FE17C0-0132-4DF8-A152-A482BA16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751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C4F63-A95C-4033-87B1-5AA8096BE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1C2DD-ECE2-4E52-A293-17936AEF5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6822AF-1F00-4EC6-AE9C-F7C3337BD6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B725F-99DA-4F9D-ACF6-99707CE02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D1B0E-A8E6-4B14-A7BE-C90A670C5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E4A7EB-713A-48B1-A22D-27465DD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60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50D42C-811D-4762-AE25-D3AF02AA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1844C-D363-4265-9552-2E8A188A3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3EEEC3-6FF1-4595-BCC0-6DF7F1711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C7D48-D5BA-499B-96DA-FF6EF2406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A08F2B-20F9-4FC2-9B4E-1B22F35A1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20E279-CD23-4EF9-A3D8-3B8D911A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A81EB6-909A-455F-A59E-70E3A871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266D316-4F8D-456E-985A-06BAF752E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22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75DAC-2DD0-4008-B087-E374FFA3E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117E92-F529-4843-BFFA-8FBB65A2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A723E4-535C-4B92-8BB4-52AE3C8F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7923EC-C2CC-457C-9819-6BCFA82BF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855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EC8F30-7F17-4408-BD44-A4E27E4AF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2BB490-E49F-45E1-9F0C-2532D6F8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D3576E-DB4A-4570-BF0D-704CA8317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44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8AB86E-44CE-4EFD-A5CD-CC8E746B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7EF18-F398-4163-ABE5-3503D99BC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C979A3C-23BA-4E66-A64A-F12F1BC68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986307-833A-4E86-AC7B-FCC5C6B39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E7E5D-048C-47AE-83F4-EF7266643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EC1F4-8E73-4482-AB71-45F243332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64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84D41-B384-4320-9E37-871EB745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988792-D6A9-4C60-BA5C-EC95425DE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37948-C344-4DD1-A290-9B4F12367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6CA909-7BFC-4C95-881A-20248B22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C32CB3-4FA8-423E-8579-D6C8E899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5325EF-82A4-450C-BE8A-25C9E318C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55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F9837-67C5-4C40-993C-F02DBA4D2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F5FDC4-8FCA-49ED-8D4A-C6E156640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AFEDC-718E-45EE-B5C0-A85AC523F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4E78E-D98B-4635-B2C6-720BB4F766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5CF415-1A74-4B42-9FC0-5B91978A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4747" y="71970"/>
            <a:ext cx="322876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1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Table S5. </a:t>
            </a:r>
            <a:r>
              <a:rPr kumimoji="0" lang="en-US" altLang="ja-JP" sz="1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rticipants’ characteristics.</a:t>
            </a:r>
          </a:p>
        </p:txBody>
      </p:sp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4340629"/>
              </p:ext>
            </p:extLst>
          </p:nvPr>
        </p:nvGraphicFramePr>
        <p:xfrm>
          <a:off x="157478" y="333580"/>
          <a:ext cx="5576694" cy="3768891"/>
        </p:xfrm>
        <a:graphic>
          <a:graphicData uri="http://schemas.openxmlformats.org/drawingml/2006/table">
            <a:tbl>
              <a:tblPr firstRow="1" firstCol="1" bandRow="1"/>
              <a:tblGrid>
                <a:gridCol w="1758127">
                  <a:extLst>
                    <a:ext uri="{9D8B030D-6E8A-4147-A177-3AD203B41FA5}">
                      <a16:colId xmlns:a16="http://schemas.microsoft.com/office/drawing/2014/main" val="4276022426"/>
                    </a:ext>
                  </a:extLst>
                </a:gridCol>
                <a:gridCol w="768566">
                  <a:extLst>
                    <a:ext uri="{9D8B030D-6E8A-4147-A177-3AD203B41FA5}">
                      <a16:colId xmlns:a16="http://schemas.microsoft.com/office/drawing/2014/main" val="3197624294"/>
                    </a:ext>
                  </a:extLst>
                </a:gridCol>
                <a:gridCol w="930542">
                  <a:extLst>
                    <a:ext uri="{9D8B030D-6E8A-4147-A177-3AD203B41FA5}">
                      <a16:colId xmlns:a16="http://schemas.microsoft.com/office/drawing/2014/main" val="3906934747"/>
                    </a:ext>
                  </a:extLst>
                </a:gridCol>
                <a:gridCol w="930542">
                  <a:extLst>
                    <a:ext uri="{9D8B030D-6E8A-4147-A177-3AD203B41FA5}">
                      <a16:colId xmlns:a16="http://schemas.microsoft.com/office/drawing/2014/main" val="1412925564"/>
                    </a:ext>
                  </a:extLst>
                </a:gridCol>
                <a:gridCol w="1188917">
                  <a:extLst>
                    <a:ext uri="{9D8B030D-6E8A-4147-A177-3AD203B41FA5}">
                      <a16:colId xmlns:a16="http://schemas.microsoft.com/office/drawing/2014/main" val="1239991743"/>
                    </a:ext>
                  </a:extLst>
                </a:gridCol>
              </a:tblGrid>
              <a:tr h="303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egory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LL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n = 4274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al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n = 2905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Femal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n = 1369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i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Valu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ale vs. Femal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1235474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e [years] </a:t>
                      </a:r>
                      <a:endParaRPr lang="ja-JP" sz="900" kern="100" baseline="300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8.12±0.19</a:t>
                      </a: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9.82±0.22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4.51±0.34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5855630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MI [kg/m</a:t>
                      </a:r>
                      <a:r>
                        <a:rPr lang="en-US" sz="900" b="1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]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2.68±0.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3.49±0.06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0.97±0.09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5621586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JB [%]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.5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.8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.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&lt; 0.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7949754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J-W B [%]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.7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.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.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80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746279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B [%]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.0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.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4623465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B [%]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.6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.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064712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at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0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5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0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3980560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Fish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4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6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0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42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961130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gg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7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4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44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5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6444038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900" kern="0"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oy</a:t>
                      </a:r>
                      <a:r>
                        <a:rPr lang="en-US" sz="900" b="1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8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2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19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9155204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Dairy products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0±0.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2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20±0.0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5798556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taple food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73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72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76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2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0462993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Vegetables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75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56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15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1570972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Fruits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4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2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0±0.0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2715199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nacks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6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8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5±0.0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8943345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Juice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0±0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7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6±0.0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8529434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lcohol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2±0.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0±0.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2±0.0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4161610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rregular amount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0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4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2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8357021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Less chewing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5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2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1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9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8426979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Large amount of food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48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53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37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908752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ating out a lot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0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1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7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8495958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utritional unbalances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55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49±0.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5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899421"/>
                  </a:ext>
                </a:extLst>
              </a:tr>
              <a:tr h="150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xcessive salt 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56±0.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0±0.0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48±0.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ja-JP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5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4305" marR="6430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5856166"/>
                  </a:ext>
                </a:extLst>
              </a:tr>
            </a:tbl>
          </a:graphicData>
        </a:graphic>
      </p:graphicFrame>
      <p:sp>
        <p:nvSpPr>
          <p:cNvPr id="8" name="Rectangle 1"/>
          <p:cNvSpPr>
            <a:spLocks noChangeArrowheads="1"/>
          </p:cNvSpPr>
          <p:nvPr/>
        </p:nvSpPr>
        <p:spPr bwMode="auto">
          <a:xfrm>
            <a:off x="94747" y="4248665"/>
            <a:ext cx="3339376" cy="23083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ta expressed as average ±SE. </a:t>
            </a:r>
            <a:r>
              <a:rPr lang="en-US" altLang="ja-JP" sz="900" kern="0" dirty="0">
                <a:highlight>
                  <a:srgbClr val="FFFF00"/>
                </a:highlight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※1  t test.. ※2 Fisher’s exact test.</a:t>
            </a:r>
            <a:endParaRPr lang="ja-JP" altLang="ja-JP" sz="9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6846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3</TotalTime>
  <Words>225</Words>
  <Application>Microsoft Office PowerPoint</Application>
  <PresentationFormat>Widescreen</PresentationFormat>
  <Paragraphs>1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shigenobu</dc:creator>
  <cp:lastModifiedBy>MDPI</cp:lastModifiedBy>
  <cp:revision>52</cp:revision>
  <cp:lastPrinted>2022-06-15T02:16:55Z</cp:lastPrinted>
  <dcterms:created xsi:type="dcterms:W3CDTF">2021-12-25T05:48:07Z</dcterms:created>
  <dcterms:modified xsi:type="dcterms:W3CDTF">2022-12-06T02:58:26Z</dcterms:modified>
</cp:coreProperties>
</file>